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C53482-4C86-DAE4-0952-CC6C58878A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25E8B38-59C0-5EBD-E579-C0FABBDFD2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C5D59FA-3C7D-5B7C-F99B-22AAEFB76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6B48B58-A4DE-DC1E-F9D2-4587AE1DB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7DC4388-01A1-3F25-5369-1B4E8706C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9534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2B7548-BF4D-4B4B-7A24-353D51E15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0A32A89-58F6-41AB-1A73-060949D645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530C9D2-F3FE-0DFB-C992-C98D25D89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463370-2284-1EBF-900E-A6ED13589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0059426-BA16-C1CD-E295-1DD28DA69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8007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E96D4CC-CE8B-F18D-D004-A84DFCDDDF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3764229-226B-F3DE-6A85-88FEF52259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C5347B0-90F2-9B07-F6D8-EF0666A93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4A48A-F22B-7A55-F8C4-7D39DCE55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DB47E31-BCE7-DF1C-8178-47D52F315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2691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45DFA6-1BF6-940C-6BAE-1C62D8A57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E5A263A-44B7-0C2C-5F36-EE74656CE8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51719E4-0A45-F3B4-A13F-31AAA192E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1F178E3-BDD1-41EF-0356-002BDAF76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7463783-4122-4B62-A2AD-DB40A0ACE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2907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C54875-D668-1F53-5616-4EFB3AA1A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6A886CF-EC76-C1F7-C543-311DAACA9F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ECE9C07-1DDE-FFA8-CF97-B9D96507B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7157EA8-B3F7-852A-B083-7A2C27F0A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6F237F-C7A8-0C8A-0338-5FFA2D87B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4119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B94F73-8D65-4311-C760-D355A91D7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E2D1C2B-EBFC-F6F3-22C9-EBE89490BE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4D79711-084D-87C4-9F6A-6CC22AAA24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5986CCB-5031-B2DA-D7C9-19C418DB5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5C35E6F-2F42-F38C-45B4-03B46A216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CB5C730-7938-0042-08C7-4D142A99C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0921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66CF53-E9D5-8991-12E1-50F7DE7CE9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9614968-C6DB-2FCA-B31E-1DB4FB277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02CBE32-89D5-355F-88CC-E7F744A1C3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3FA530A-4651-79FF-EF4B-AF79777BED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E2BDA1F-9342-82D1-FA51-217B5229F2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8585443-AA21-C2BE-D486-B2665A4D6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D5EFA38-0F55-067C-E9C8-3E298CA40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817C4BC-6493-75F2-F02B-83B12AB19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1384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27B24FF-4BAB-CDE8-E686-F72DA6457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8C30E76-33EE-62EF-B22C-A10846EC8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C21DC78-E86E-8C8E-8E13-0A12F6805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AD23346-EA28-76E7-F931-61A82764F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2835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5199F48-291A-06A8-56C6-56B9AE9E7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50B8A17-3BF9-DAC7-73FE-67CD29AEE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3CB8412-757B-E6C0-53E5-48D9D497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9935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255CBE-0F28-77CE-F536-1E1E99785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D860DA1-3587-AFE1-2F66-BBF2CA4B1A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2768835-7F7D-21F5-6D37-C65D85DF6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AD1C84C-D76D-4102-BE18-11B64DE3F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C71CDD-BAC2-0801-3C1C-9B9A5A8AD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042CEC2-C80F-D249-1D40-A78EC35A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3439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7538BAC-B072-A3CC-7E03-499C30047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736F25A-D61F-C096-BF50-7F6D82BB20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9DCF9D6-4888-14EF-EB7F-45C6DE6D1E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DA0D9AF-83CB-E72A-1B15-CB8DCA87A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D1BBAE9-CCF0-A48D-C4EC-5281EB828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7BD5371-DC57-1410-C55A-5988DB11B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7693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6DAA773-D749-CF04-E79D-90AA9E800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61AD86F-7429-5519-F94D-C2A99C3EDD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30BDAF-2A5A-9324-FF44-17FA8D4DAC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C73891-FB4E-4972-9ABB-3EDD16E09B25}" type="datetimeFigureOut">
              <a:rPr lang="it-IT" smtClean="0"/>
              <a:t>21/07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7CD915-15FD-3ACF-069C-555E1324FF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BD3A5C-0978-77D3-C289-3AB27A651A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1206A8-45F4-4055-8383-F3A0A5DE1E9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6842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8A22FF06-74AD-21B0-7F19-F7EE9BE77C90}"/>
              </a:ext>
            </a:extLst>
          </p:cNvPr>
          <p:cNvSpPr txBox="1"/>
          <p:nvPr/>
        </p:nvSpPr>
        <p:spPr>
          <a:xfrm>
            <a:off x="1258529" y="393289"/>
            <a:ext cx="109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1 D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0300402A-16FE-E3DD-7C05-424E8983E86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774" t="20154" r="9387" b="26513"/>
          <a:stretch>
            <a:fillRect/>
          </a:stretch>
        </p:blipFill>
        <p:spPr>
          <a:xfrm>
            <a:off x="1049428" y="1373237"/>
            <a:ext cx="5425440" cy="2641600"/>
          </a:xfrm>
          <a:prstGeom prst="rect">
            <a:avLst/>
          </a:prstGeom>
        </p:spPr>
      </p:pic>
      <p:sp>
        <p:nvSpPr>
          <p:cNvPr id="7" name="Rettangolo 6">
            <a:extLst>
              <a:ext uri="{FF2B5EF4-FFF2-40B4-BE49-F238E27FC236}">
                <a16:creationId xmlns:a16="http://schemas.microsoft.com/office/drawing/2014/main" id="{06F5CF92-0A59-1FC3-D662-EC8AA1AD7871}"/>
              </a:ext>
            </a:extLst>
          </p:cNvPr>
          <p:cNvSpPr/>
          <p:nvPr/>
        </p:nvSpPr>
        <p:spPr>
          <a:xfrm>
            <a:off x="1699668" y="2320418"/>
            <a:ext cx="4111195" cy="6956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B05DC05-5E81-FDDB-59F2-96C15B78C847}"/>
              </a:ext>
            </a:extLst>
          </p:cNvPr>
          <p:cNvSpPr txBox="1"/>
          <p:nvPr/>
        </p:nvSpPr>
        <p:spPr>
          <a:xfrm>
            <a:off x="2143433" y="1445342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B859D9D-3B50-DF1C-5653-524A3CB8F8AB}"/>
              </a:ext>
            </a:extLst>
          </p:cNvPr>
          <p:cNvSpPr txBox="1"/>
          <p:nvPr/>
        </p:nvSpPr>
        <p:spPr>
          <a:xfrm>
            <a:off x="4240324" y="1461113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" name="Connettore diritto 10">
            <a:extLst>
              <a:ext uri="{FF2B5EF4-FFF2-40B4-BE49-F238E27FC236}">
                <a16:creationId xmlns:a16="http://schemas.microsoft.com/office/drawing/2014/main" id="{54BCE9F3-FCE8-5E5D-55B6-9586B0A86F03}"/>
              </a:ext>
            </a:extLst>
          </p:cNvPr>
          <p:cNvCxnSpPr/>
          <p:nvPr/>
        </p:nvCxnSpPr>
        <p:spPr>
          <a:xfrm>
            <a:off x="2005781" y="1740310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194EAF1B-72AF-AD89-7FFD-D4FDA0074E29}"/>
              </a:ext>
            </a:extLst>
          </p:cNvPr>
          <p:cNvCxnSpPr/>
          <p:nvPr/>
        </p:nvCxnSpPr>
        <p:spPr>
          <a:xfrm>
            <a:off x="4036142" y="1740310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Immagine 13">
            <a:extLst>
              <a:ext uri="{FF2B5EF4-FFF2-40B4-BE49-F238E27FC236}">
                <a16:creationId xmlns:a16="http://schemas.microsoft.com/office/drawing/2014/main" id="{C3A4F3B2-34F1-D25F-E1D3-BDD396BF021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1291" t="23681" r="13219" b="32535"/>
          <a:stretch>
            <a:fillRect/>
          </a:stretch>
        </p:blipFill>
        <p:spPr>
          <a:xfrm>
            <a:off x="1470249" y="4381910"/>
            <a:ext cx="5004619" cy="2168622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012C0C10-EEEB-AFA7-B5BC-26CE7BD9D0C5}"/>
              </a:ext>
            </a:extLst>
          </p:cNvPr>
          <p:cNvSpPr txBox="1"/>
          <p:nvPr/>
        </p:nvSpPr>
        <p:spPr>
          <a:xfrm>
            <a:off x="6033727" y="2483568"/>
            <a:ext cx="1091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MM20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B8972FE-B804-143E-02DB-1EC587CED17C}"/>
              </a:ext>
            </a:extLst>
          </p:cNvPr>
          <p:cNvSpPr txBox="1"/>
          <p:nvPr/>
        </p:nvSpPr>
        <p:spPr>
          <a:xfrm>
            <a:off x="5929177" y="5212020"/>
            <a:ext cx="1091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PDH</a:t>
            </a: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66F1E6C5-91AD-BB04-15E0-02A69FB91556}"/>
              </a:ext>
            </a:extLst>
          </p:cNvPr>
          <p:cNvSpPr/>
          <p:nvPr/>
        </p:nvSpPr>
        <p:spPr>
          <a:xfrm>
            <a:off x="2005781" y="5212020"/>
            <a:ext cx="3670052" cy="500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2F96EFCA-902C-8C51-3B81-D9EB141A97D6}"/>
              </a:ext>
            </a:extLst>
          </p:cNvPr>
          <p:cNvSpPr txBox="1"/>
          <p:nvPr/>
        </p:nvSpPr>
        <p:spPr>
          <a:xfrm>
            <a:off x="2281085" y="4853431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EC7F5A4E-9FF7-1A33-9B77-DE410D6D9018}"/>
              </a:ext>
            </a:extLst>
          </p:cNvPr>
          <p:cNvSpPr txBox="1"/>
          <p:nvPr/>
        </p:nvSpPr>
        <p:spPr>
          <a:xfrm>
            <a:off x="4337336" y="4869202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4" name="Connettore diritto 23">
            <a:extLst>
              <a:ext uri="{FF2B5EF4-FFF2-40B4-BE49-F238E27FC236}">
                <a16:creationId xmlns:a16="http://schemas.microsoft.com/office/drawing/2014/main" id="{3CE638ED-B83C-C9A5-67BB-4B28A83DF5B3}"/>
              </a:ext>
            </a:extLst>
          </p:cNvPr>
          <p:cNvCxnSpPr/>
          <p:nvPr/>
        </p:nvCxnSpPr>
        <p:spPr>
          <a:xfrm>
            <a:off x="2143433" y="5148399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diritto 24">
            <a:extLst>
              <a:ext uri="{FF2B5EF4-FFF2-40B4-BE49-F238E27FC236}">
                <a16:creationId xmlns:a16="http://schemas.microsoft.com/office/drawing/2014/main" id="{72CD69B8-8095-2653-53FE-A6A82833033C}"/>
              </a:ext>
            </a:extLst>
          </p:cNvPr>
          <p:cNvCxnSpPr/>
          <p:nvPr/>
        </p:nvCxnSpPr>
        <p:spPr>
          <a:xfrm>
            <a:off x="4173794" y="5148399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AC89F13-DDF5-5B24-38AA-DDB178E0EB78}"/>
              </a:ext>
            </a:extLst>
          </p:cNvPr>
          <p:cNvSpPr txBox="1"/>
          <p:nvPr/>
        </p:nvSpPr>
        <p:spPr>
          <a:xfrm>
            <a:off x="469981" y="2338230"/>
            <a:ext cx="1091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 </a:t>
            </a:r>
            <a:r>
              <a:rPr lang="it-IT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4B8D3CBB-38F4-59A2-CD11-0A9EA39731F1}"/>
              </a:ext>
            </a:extLst>
          </p:cNvPr>
          <p:cNvSpPr txBox="1"/>
          <p:nvPr/>
        </p:nvSpPr>
        <p:spPr>
          <a:xfrm>
            <a:off x="573877" y="5280844"/>
            <a:ext cx="1091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 </a:t>
            </a:r>
            <a:r>
              <a:rPr lang="it-IT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8436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1307382-40A7-D099-06A5-1BBD266D5EFA}"/>
              </a:ext>
            </a:extLst>
          </p:cNvPr>
          <p:cNvSpPr txBox="1"/>
          <p:nvPr/>
        </p:nvSpPr>
        <p:spPr>
          <a:xfrm>
            <a:off x="518160" y="133573"/>
            <a:ext cx="109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3 A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D2800735-46F8-9DCF-B3F3-02A2EBDA221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632" r="8739" b="22496"/>
          <a:stretch>
            <a:fillRect/>
          </a:stretch>
        </p:blipFill>
        <p:spPr>
          <a:xfrm>
            <a:off x="496694" y="946601"/>
            <a:ext cx="5080000" cy="3838759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67018D87-0618-5205-C96C-D8E0306561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7168" y="946601"/>
            <a:ext cx="4936356" cy="3688080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516F5927-1BD1-040E-C745-44AF5530F674}"/>
              </a:ext>
            </a:extLst>
          </p:cNvPr>
          <p:cNvSpPr txBox="1"/>
          <p:nvPr/>
        </p:nvSpPr>
        <p:spPr>
          <a:xfrm>
            <a:off x="1202404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ACE016E-A1A6-A7B6-8929-C3C72931F3AF}"/>
              </a:ext>
            </a:extLst>
          </p:cNvPr>
          <p:cNvSpPr txBox="1"/>
          <p:nvPr/>
        </p:nvSpPr>
        <p:spPr>
          <a:xfrm>
            <a:off x="3322156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" name="Connettore diritto 10">
            <a:extLst>
              <a:ext uri="{FF2B5EF4-FFF2-40B4-BE49-F238E27FC236}">
                <a16:creationId xmlns:a16="http://schemas.microsoft.com/office/drawing/2014/main" id="{B5C38FE2-060D-719E-46BD-5B4F0083707F}"/>
              </a:ext>
            </a:extLst>
          </p:cNvPr>
          <p:cNvCxnSpPr/>
          <p:nvPr/>
        </p:nvCxnSpPr>
        <p:spPr>
          <a:xfrm>
            <a:off x="1064752" y="872237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F800616C-933C-77DB-03AC-0E93FA24A237}"/>
              </a:ext>
            </a:extLst>
          </p:cNvPr>
          <p:cNvCxnSpPr/>
          <p:nvPr/>
        </p:nvCxnSpPr>
        <p:spPr>
          <a:xfrm>
            <a:off x="3097654" y="856466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104AAB61-5405-4DCB-80B5-FC9C7C089756}"/>
              </a:ext>
            </a:extLst>
          </p:cNvPr>
          <p:cNvSpPr txBox="1"/>
          <p:nvPr/>
        </p:nvSpPr>
        <p:spPr>
          <a:xfrm>
            <a:off x="6337057" y="577269"/>
            <a:ext cx="2502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ain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ree membrane</a:t>
            </a: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F2954AFB-9388-AF75-B748-251261A2B9D5}"/>
              </a:ext>
            </a:extLst>
          </p:cNvPr>
          <p:cNvSpPr/>
          <p:nvPr/>
        </p:nvSpPr>
        <p:spPr>
          <a:xfrm>
            <a:off x="958312" y="2310258"/>
            <a:ext cx="4233448" cy="2038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842A33D7-8002-2B52-CED0-DCA0CFCFC28D}"/>
              </a:ext>
            </a:extLst>
          </p:cNvPr>
          <p:cNvSpPr txBox="1"/>
          <p:nvPr/>
        </p:nvSpPr>
        <p:spPr>
          <a:xfrm>
            <a:off x="180360" y="2146142"/>
            <a:ext cx="4981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CB3B134C-0C51-04E8-2E95-704E89432101}"/>
              </a:ext>
            </a:extLst>
          </p:cNvPr>
          <p:cNvSpPr txBox="1"/>
          <p:nvPr/>
        </p:nvSpPr>
        <p:spPr>
          <a:xfrm>
            <a:off x="206400" y="2704863"/>
            <a:ext cx="4010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48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BBF76A9-3A76-F965-75D4-21918655D40A}"/>
              </a:ext>
            </a:extLst>
          </p:cNvPr>
          <p:cNvSpPr txBox="1"/>
          <p:nvPr/>
        </p:nvSpPr>
        <p:spPr>
          <a:xfrm>
            <a:off x="216991" y="2399897"/>
            <a:ext cx="3741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55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581C5CF-395D-5C29-81DB-304B492053B4}"/>
              </a:ext>
            </a:extLst>
          </p:cNvPr>
          <p:cNvSpPr txBox="1"/>
          <p:nvPr/>
        </p:nvSpPr>
        <p:spPr>
          <a:xfrm>
            <a:off x="236520" y="3020334"/>
            <a:ext cx="3438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30747538-3A9F-7F97-35F8-4788C58D05CC}"/>
              </a:ext>
            </a:extLst>
          </p:cNvPr>
          <p:cNvSpPr txBox="1"/>
          <p:nvPr/>
        </p:nvSpPr>
        <p:spPr>
          <a:xfrm>
            <a:off x="236520" y="3479800"/>
            <a:ext cx="3826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30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6D71442-C291-9B8B-1A4A-F95B5691C77C}"/>
              </a:ext>
            </a:extLst>
          </p:cNvPr>
          <p:cNvSpPr txBox="1"/>
          <p:nvPr/>
        </p:nvSpPr>
        <p:spPr>
          <a:xfrm>
            <a:off x="237838" y="3938184"/>
            <a:ext cx="3385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F8D0FFE7-EDC5-40B9-D704-1B6D0767C7E1}"/>
              </a:ext>
            </a:extLst>
          </p:cNvPr>
          <p:cNvSpPr txBox="1"/>
          <p:nvPr/>
        </p:nvSpPr>
        <p:spPr>
          <a:xfrm>
            <a:off x="5399729" y="2310258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V ATP5A 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D574C29D-3428-79CF-C2A8-344DF3233F64}"/>
              </a:ext>
            </a:extLst>
          </p:cNvPr>
          <p:cNvSpPr txBox="1"/>
          <p:nvPr/>
        </p:nvSpPr>
        <p:spPr>
          <a:xfrm>
            <a:off x="5400150" y="2956577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V MTCO1 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164BD02E-4B9C-03C6-4A1F-A48D1C5D00B1}"/>
              </a:ext>
            </a:extLst>
          </p:cNvPr>
          <p:cNvSpPr txBox="1"/>
          <p:nvPr/>
        </p:nvSpPr>
        <p:spPr>
          <a:xfrm>
            <a:off x="5407770" y="3979795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 NDUFB8 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B8C5A13E-1830-15F8-8E00-022DDA78CC8F}"/>
              </a:ext>
            </a:extLst>
          </p:cNvPr>
          <p:cNvSpPr txBox="1"/>
          <p:nvPr/>
        </p:nvSpPr>
        <p:spPr>
          <a:xfrm>
            <a:off x="5396679" y="2582235"/>
            <a:ext cx="9140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II UQCRC2 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98DF977-AA8B-40A2-1E00-80D7E2613CAE}"/>
              </a:ext>
            </a:extLst>
          </p:cNvPr>
          <p:cNvSpPr txBox="1"/>
          <p:nvPr/>
        </p:nvSpPr>
        <p:spPr>
          <a:xfrm>
            <a:off x="5409784" y="3475368"/>
            <a:ext cx="8402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I SDHB </a:t>
            </a:r>
          </a:p>
        </p:txBody>
      </p:sp>
    </p:spTree>
    <p:extLst>
      <p:ext uri="{BB962C8B-B14F-4D97-AF65-F5344CB8AC3E}">
        <p14:creationId xmlns:p14="http://schemas.microsoft.com/office/powerpoint/2010/main" val="1070487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1847D67-D110-8532-66C4-D2668815578D}"/>
              </a:ext>
            </a:extLst>
          </p:cNvPr>
          <p:cNvSpPr txBox="1"/>
          <p:nvPr/>
        </p:nvSpPr>
        <p:spPr>
          <a:xfrm>
            <a:off x="821649" y="118969"/>
            <a:ext cx="109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4 A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905DFAB4-DD39-84C7-C696-83C99E40BB8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3065" t="35539" r="15365" b="34513"/>
          <a:stretch>
            <a:fillRect/>
          </a:stretch>
        </p:blipFill>
        <p:spPr>
          <a:xfrm>
            <a:off x="470310" y="782255"/>
            <a:ext cx="4744720" cy="148336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92722E9A-276B-54F7-7774-3B5BE153A7AB}"/>
              </a:ext>
            </a:extLst>
          </p:cNvPr>
          <p:cNvSpPr txBox="1"/>
          <p:nvPr/>
        </p:nvSpPr>
        <p:spPr>
          <a:xfrm>
            <a:off x="1202404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DE792FB-2EE2-F1C8-0978-A5C8CE82558C}"/>
              </a:ext>
            </a:extLst>
          </p:cNvPr>
          <p:cNvSpPr txBox="1"/>
          <p:nvPr/>
        </p:nvSpPr>
        <p:spPr>
          <a:xfrm>
            <a:off x="3322156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E99D4756-B833-0CDF-73C1-0308E0EE36AB}"/>
              </a:ext>
            </a:extLst>
          </p:cNvPr>
          <p:cNvCxnSpPr/>
          <p:nvPr/>
        </p:nvCxnSpPr>
        <p:spPr>
          <a:xfrm>
            <a:off x="1064752" y="872237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diritto 9">
            <a:extLst>
              <a:ext uri="{FF2B5EF4-FFF2-40B4-BE49-F238E27FC236}">
                <a16:creationId xmlns:a16="http://schemas.microsoft.com/office/drawing/2014/main" id="{82F67E38-F1C9-754D-7FA2-4101F4CBFF17}"/>
              </a:ext>
            </a:extLst>
          </p:cNvPr>
          <p:cNvCxnSpPr/>
          <p:nvPr/>
        </p:nvCxnSpPr>
        <p:spPr>
          <a:xfrm>
            <a:off x="3097654" y="856466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ettangolo 10">
            <a:extLst>
              <a:ext uri="{FF2B5EF4-FFF2-40B4-BE49-F238E27FC236}">
                <a16:creationId xmlns:a16="http://schemas.microsoft.com/office/drawing/2014/main" id="{DDF333E4-0B31-EFF3-9D73-66B62A91C4F4}"/>
              </a:ext>
            </a:extLst>
          </p:cNvPr>
          <p:cNvSpPr/>
          <p:nvPr/>
        </p:nvSpPr>
        <p:spPr>
          <a:xfrm>
            <a:off x="1014854" y="1645860"/>
            <a:ext cx="3670052" cy="500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FC98D592-218E-E88C-93D3-4407304F6AB8}"/>
              </a:ext>
            </a:extLst>
          </p:cNvPr>
          <p:cNvSpPr txBox="1"/>
          <p:nvPr/>
        </p:nvSpPr>
        <p:spPr>
          <a:xfrm>
            <a:off x="5048209" y="1711455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FN1</a:t>
            </a:r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43684CE7-A94E-5610-B4B7-424939B1954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540" t="43273" r="14597" b="31642"/>
          <a:stretch>
            <a:fillRect/>
          </a:stretch>
        </p:blipFill>
        <p:spPr>
          <a:xfrm>
            <a:off x="335280" y="2474693"/>
            <a:ext cx="5029200" cy="1242418"/>
          </a:xfrm>
          <a:prstGeom prst="rect">
            <a:avLst/>
          </a:prstGeom>
        </p:spPr>
      </p:pic>
      <p:sp>
        <p:nvSpPr>
          <p:cNvPr id="15" name="Rettangolo 14">
            <a:extLst>
              <a:ext uri="{FF2B5EF4-FFF2-40B4-BE49-F238E27FC236}">
                <a16:creationId xmlns:a16="http://schemas.microsoft.com/office/drawing/2014/main" id="{C76518DF-0368-20DB-F481-649CE978B687}"/>
              </a:ext>
            </a:extLst>
          </p:cNvPr>
          <p:cNvSpPr/>
          <p:nvPr/>
        </p:nvSpPr>
        <p:spPr>
          <a:xfrm>
            <a:off x="951602" y="3216589"/>
            <a:ext cx="3670052" cy="500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BAD0687-5F39-FF6A-FDA4-FD0A56EA3A59}"/>
              </a:ext>
            </a:extLst>
          </p:cNvPr>
          <p:cNvSpPr txBox="1"/>
          <p:nvPr/>
        </p:nvSpPr>
        <p:spPr>
          <a:xfrm>
            <a:off x="5282711" y="3064189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P1</a:t>
            </a:r>
          </a:p>
        </p:txBody>
      </p:sp>
      <p:pic>
        <p:nvPicPr>
          <p:cNvPr id="20" name="Immagine 19">
            <a:extLst>
              <a:ext uri="{FF2B5EF4-FFF2-40B4-BE49-F238E27FC236}">
                <a16:creationId xmlns:a16="http://schemas.microsoft.com/office/drawing/2014/main" id="{C141F671-D447-24EC-B515-DD0F7306B8C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337" t="32057" r="23027" b="44183"/>
          <a:stretch>
            <a:fillRect/>
          </a:stretch>
        </p:blipFill>
        <p:spPr>
          <a:xfrm>
            <a:off x="416560" y="3946509"/>
            <a:ext cx="4947920" cy="1176823"/>
          </a:xfrm>
          <a:prstGeom prst="rect">
            <a:avLst/>
          </a:prstGeom>
        </p:spPr>
      </p:pic>
      <p:sp>
        <p:nvSpPr>
          <p:cNvPr id="21" name="Rettangolo 20">
            <a:extLst>
              <a:ext uri="{FF2B5EF4-FFF2-40B4-BE49-F238E27FC236}">
                <a16:creationId xmlns:a16="http://schemas.microsoft.com/office/drawing/2014/main" id="{491E8A8C-A85F-11A7-F02C-05140840A997}"/>
              </a:ext>
            </a:extLst>
          </p:cNvPr>
          <p:cNvSpPr/>
          <p:nvPr/>
        </p:nvSpPr>
        <p:spPr>
          <a:xfrm>
            <a:off x="1087613" y="4208746"/>
            <a:ext cx="3670052" cy="500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FB50250-0D60-D68D-97E6-AF2465C97DF5}"/>
              </a:ext>
            </a:extLst>
          </p:cNvPr>
          <p:cNvSpPr txBox="1"/>
          <p:nvPr/>
        </p:nvSpPr>
        <p:spPr>
          <a:xfrm>
            <a:off x="5215030" y="4306607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S1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1BA9D7E9-76ED-92F2-244D-37FCC4B216B5}"/>
              </a:ext>
            </a:extLst>
          </p:cNvPr>
          <p:cNvSpPr txBox="1"/>
          <p:nvPr/>
        </p:nvSpPr>
        <p:spPr>
          <a:xfrm>
            <a:off x="-26629" y="1683037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6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CE5BBE3A-C36F-83C8-49AE-5773055A64C2}"/>
              </a:ext>
            </a:extLst>
          </p:cNvPr>
          <p:cNvSpPr txBox="1"/>
          <p:nvPr/>
        </p:nvSpPr>
        <p:spPr>
          <a:xfrm>
            <a:off x="-26629" y="3290500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0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FEFFEF4-E9C2-86E8-5F92-49A36A1F948F}"/>
              </a:ext>
            </a:extLst>
          </p:cNvPr>
          <p:cNvSpPr txBox="1"/>
          <p:nvPr/>
        </p:nvSpPr>
        <p:spPr>
          <a:xfrm>
            <a:off x="0" y="4268701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7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7" name="Immagine 26">
            <a:extLst>
              <a:ext uri="{FF2B5EF4-FFF2-40B4-BE49-F238E27FC236}">
                <a16:creationId xmlns:a16="http://schemas.microsoft.com/office/drawing/2014/main" id="{645EBDE6-E8CC-0BF4-433F-E2D9A96EFF7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724" t="47204" r="20421" b="24824"/>
          <a:stretch>
            <a:fillRect/>
          </a:stretch>
        </p:blipFill>
        <p:spPr>
          <a:xfrm>
            <a:off x="416560" y="5183287"/>
            <a:ext cx="5161280" cy="1385439"/>
          </a:xfrm>
          <a:prstGeom prst="rect">
            <a:avLst/>
          </a:prstGeom>
        </p:spPr>
      </p:pic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C6131370-828D-58CD-D83B-0C9C524DF8EA}"/>
              </a:ext>
            </a:extLst>
          </p:cNvPr>
          <p:cNvSpPr txBox="1"/>
          <p:nvPr/>
        </p:nvSpPr>
        <p:spPr>
          <a:xfrm>
            <a:off x="5364480" y="5753403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MFN2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D29DC998-283D-5FE0-85ED-B02A27D1D665}"/>
              </a:ext>
            </a:extLst>
          </p:cNvPr>
          <p:cNvSpPr txBox="1"/>
          <p:nvPr/>
        </p:nvSpPr>
        <p:spPr>
          <a:xfrm>
            <a:off x="-47687" y="6259234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6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Rettangolo 29">
            <a:extLst>
              <a:ext uri="{FF2B5EF4-FFF2-40B4-BE49-F238E27FC236}">
                <a16:creationId xmlns:a16="http://schemas.microsoft.com/office/drawing/2014/main" id="{9CDCBEFA-5245-5A6C-4DDB-0FF52924F95D}"/>
              </a:ext>
            </a:extLst>
          </p:cNvPr>
          <p:cNvSpPr/>
          <p:nvPr/>
        </p:nvSpPr>
        <p:spPr>
          <a:xfrm>
            <a:off x="1087612" y="6001534"/>
            <a:ext cx="3748547" cy="5671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D91EFE81-34D4-0569-1B5D-5E91A6AC9136}"/>
              </a:ext>
            </a:extLst>
          </p:cNvPr>
          <p:cNvSpPr txBox="1"/>
          <p:nvPr/>
        </p:nvSpPr>
        <p:spPr>
          <a:xfrm>
            <a:off x="7064724" y="577204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BF4C540A-B141-CD4A-C685-AA1EE2534F31}"/>
              </a:ext>
            </a:extLst>
          </p:cNvPr>
          <p:cNvSpPr txBox="1"/>
          <p:nvPr/>
        </p:nvSpPr>
        <p:spPr>
          <a:xfrm>
            <a:off x="9184476" y="577204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L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5" name="Connettore diritto 34">
            <a:extLst>
              <a:ext uri="{FF2B5EF4-FFF2-40B4-BE49-F238E27FC236}">
                <a16:creationId xmlns:a16="http://schemas.microsoft.com/office/drawing/2014/main" id="{7FD84F79-087B-33AF-8296-9B8A2BED272B}"/>
              </a:ext>
            </a:extLst>
          </p:cNvPr>
          <p:cNvCxnSpPr/>
          <p:nvPr/>
        </p:nvCxnSpPr>
        <p:spPr>
          <a:xfrm>
            <a:off x="6927072" y="872172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nettore diritto 35">
            <a:extLst>
              <a:ext uri="{FF2B5EF4-FFF2-40B4-BE49-F238E27FC236}">
                <a16:creationId xmlns:a16="http://schemas.microsoft.com/office/drawing/2014/main" id="{64A7D8BE-3E83-FD85-8F02-584122725BB6}"/>
              </a:ext>
            </a:extLst>
          </p:cNvPr>
          <p:cNvCxnSpPr/>
          <p:nvPr/>
        </p:nvCxnSpPr>
        <p:spPr>
          <a:xfrm>
            <a:off x="8959974" y="856401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8" name="Immagine 37">
            <a:extLst>
              <a:ext uri="{FF2B5EF4-FFF2-40B4-BE49-F238E27FC236}">
                <a16:creationId xmlns:a16="http://schemas.microsoft.com/office/drawing/2014/main" id="{4DF82FB8-ADE0-C828-0CA6-364A567A646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9540" t="60334" r="9081" b="24152"/>
          <a:stretch>
            <a:fillRect/>
          </a:stretch>
        </p:blipFill>
        <p:spPr>
          <a:xfrm>
            <a:off x="6306411" y="934660"/>
            <a:ext cx="5394960" cy="768400"/>
          </a:xfrm>
          <a:prstGeom prst="rect">
            <a:avLst/>
          </a:prstGeom>
        </p:spPr>
      </p:pic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5315597F-6A62-50FC-4DAB-0F021AED4369}"/>
              </a:ext>
            </a:extLst>
          </p:cNvPr>
          <p:cNvSpPr txBox="1"/>
          <p:nvPr/>
        </p:nvSpPr>
        <p:spPr>
          <a:xfrm>
            <a:off x="11377889" y="1338077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NK1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667BB3C9-A8ED-1536-73FD-629A2CE1868F}"/>
              </a:ext>
            </a:extLst>
          </p:cNvPr>
          <p:cNvSpPr txBox="1"/>
          <p:nvPr/>
        </p:nvSpPr>
        <p:spPr>
          <a:xfrm>
            <a:off x="5795296" y="1001209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Rettangolo 40">
            <a:extLst>
              <a:ext uri="{FF2B5EF4-FFF2-40B4-BE49-F238E27FC236}">
                <a16:creationId xmlns:a16="http://schemas.microsoft.com/office/drawing/2014/main" id="{D4149543-0042-9825-36F8-C991DCDD76DF}"/>
              </a:ext>
            </a:extLst>
          </p:cNvPr>
          <p:cNvSpPr/>
          <p:nvPr/>
        </p:nvSpPr>
        <p:spPr>
          <a:xfrm>
            <a:off x="7009254" y="995621"/>
            <a:ext cx="4268346" cy="277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3" name="Immagine 42">
            <a:extLst>
              <a:ext uri="{FF2B5EF4-FFF2-40B4-BE49-F238E27FC236}">
                <a16:creationId xmlns:a16="http://schemas.microsoft.com/office/drawing/2014/main" id="{6E78C57E-051C-E4D6-369E-94440A93A675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2605" t="20342" r="15823" b="51773"/>
          <a:stretch>
            <a:fillRect/>
          </a:stretch>
        </p:blipFill>
        <p:spPr>
          <a:xfrm>
            <a:off x="6393756" y="1746205"/>
            <a:ext cx="4867130" cy="1416784"/>
          </a:xfrm>
          <a:prstGeom prst="rect">
            <a:avLst/>
          </a:prstGeom>
        </p:spPr>
      </p:pic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9B73D6F1-8397-9317-2D5F-FC9F4987DCEF}"/>
              </a:ext>
            </a:extLst>
          </p:cNvPr>
          <p:cNvSpPr txBox="1"/>
          <p:nvPr/>
        </p:nvSpPr>
        <p:spPr>
          <a:xfrm>
            <a:off x="5815414" y="2362338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0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4A7B1543-507C-2D9E-56F8-3CE4C0E9D6D5}"/>
              </a:ext>
            </a:extLst>
          </p:cNvPr>
          <p:cNvSpPr txBox="1"/>
          <p:nvPr/>
        </p:nvSpPr>
        <p:spPr>
          <a:xfrm>
            <a:off x="11241222" y="2470874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PA1</a:t>
            </a:r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B6FD8019-C039-B727-7126-A2A9DD284C94}"/>
              </a:ext>
            </a:extLst>
          </p:cNvPr>
          <p:cNvSpPr/>
          <p:nvPr/>
        </p:nvSpPr>
        <p:spPr>
          <a:xfrm>
            <a:off x="7202501" y="2501354"/>
            <a:ext cx="3407323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8" name="Immagine 47">
            <a:extLst>
              <a:ext uri="{FF2B5EF4-FFF2-40B4-BE49-F238E27FC236}">
                <a16:creationId xmlns:a16="http://schemas.microsoft.com/office/drawing/2014/main" id="{8703FD7A-1813-0B39-4460-FA2A0F123ACB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9349" t="28464" r="10501" b="51418"/>
          <a:stretch>
            <a:fillRect/>
          </a:stretch>
        </p:blipFill>
        <p:spPr>
          <a:xfrm>
            <a:off x="6634707" y="3679837"/>
            <a:ext cx="4650534" cy="996413"/>
          </a:xfrm>
          <a:prstGeom prst="rect">
            <a:avLst/>
          </a:prstGeom>
        </p:spPr>
      </p:pic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C20309EC-2452-AEBF-8E3A-15A17675CF60}"/>
              </a:ext>
            </a:extLst>
          </p:cNvPr>
          <p:cNvSpPr txBox="1"/>
          <p:nvPr/>
        </p:nvSpPr>
        <p:spPr>
          <a:xfrm>
            <a:off x="5937537" y="3967137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18D87E1D-9915-AADD-20E4-37D6F60B8013}"/>
              </a:ext>
            </a:extLst>
          </p:cNvPr>
          <p:cNvSpPr txBox="1"/>
          <p:nvPr/>
        </p:nvSpPr>
        <p:spPr>
          <a:xfrm>
            <a:off x="11104387" y="3991822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PDH</a:t>
            </a:r>
          </a:p>
        </p:txBody>
      </p:sp>
      <p:sp>
        <p:nvSpPr>
          <p:cNvPr id="51" name="Rettangolo 50">
            <a:extLst>
              <a:ext uri="{FF2B5EF4-FFF2-40B4-BE49-F238E27FC236}">
                <a16:creationId xmlns:a16="http://schemas.microsoft.com/office/drawing/2014/main" id="{8C553E34-DBCD-94CF-AE48-89BBAFC4C15C}"/>
              </a:ext>
            </a:extLst>
          </p:cNvPr>
          <p:cNvSpPr/>
          <p:nvPr/>
        </p:nvSpPr>
        <p:spPr>
          <a:xfrm>
            <a:off x="6906795" y="3952304"/>
            <a:ext cx="4066005" cy="3543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0930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AADA063-0058-A586-6D3F-A65E6498B2F7}"/>
              </a:ext>
            </a:extLst>
          </p:cNvPr>
          <p:cNvSpPr txBox="1"/>
          <p:nvPr/>
        </p:nvSpPr>
        <p:spPr>
          <a:xfrm>
            <a:off x="40147" y="75809"/>
            <a:ext cx="109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6 A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00723D30-43AF-A896-0AF5-9032008FB97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475" t="14000" r="7854" b="40256"/>
          <a:stretch>
            <a:fillRect/>
          </a:stretch>
        </p:blipFill>
        <p:spPr>
          <a:xfrm>
            <a:off x="416560" y="763281"/>
            <a:ext cx="5679440" cy="2265680"/>
          </a:xfrm>
          <a:prstGeom prst="rect">
            <a:avLst/>
          </a:prstGeom>
        </p:spPr>
      </p:pic>
      <p:sp>
        <p:nvSpPr>
          <p:cNvPr id="7" name="Rettangolo 6">
            <a:extLst>
              <a:ext uri="{FF2B5EF4-FFF2-40B4-BE49-F238E27FC236}">
                <a16:creationId xmlns:a16="http://schemas.microsoft.com/office/drawing/2014/main" id="{CA403B83-64DD-AAC0-88E7-7ADCFB008A28}"/>
              </a:ext>
            </a:extLst>
          </p:cNvPr>
          <p:cNvSpPr/>
          <p:nvPr/>
        </p:nvSpPr>
        <p:spPr>
          <a:xfrm>
            <a:off x="1026160" y="1249680"/>
            <a:ext cx="4094480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E98121B-6279-1338-F880-929833415F8C}"/>
              </a:ext>
            </a:extLst>
          </p:cNvPr>
          <p:cNvSpPr txBox="1"/>
          <p:nvPr/>
        </p:nvSpPr>
        <p:spPr>
          <a:xfrm>
            <a:off x="5501147" y="1370259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03576ED-5657-5625-230D-F1B4C8B57699}"/>
              </a:ext>
            </a:extLst>
          </p:cNvPr>
          <p:cNvSpPr txBox="1"/>
          <p:nvPr/>
        </p:nvSpPr>
        <p:spPr>
          <a:xfrm>
            <a:off x="93734" y="1370259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5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A23C66A3-B39C-04BF-44A0-0A5EAE6F988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1532" t="43744" r="13065" b="26101"/>
          <a:stretch>
            <a:fillRect/>
          </a:stretch>
        </p:blipFill>
        <p:spPr>
          <a:xfrm>
            <a:off x="679409" y="3429000"/>
            <a:ext cx="4998720" cy="149352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E307EC0-7682-4117-EBD2-9FFFDA9C5C64}"/>
              </a:ext>
            </a:extLst>
          </p:cNvPr>
          <p:cNvSpPr txBox="1"/>
          <p:nvPr/>
        </p:nvSpPr>
        <p:spPr>
          <a:xfrm>
            <a:off x="5550309" y="4384250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FN2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C00AFB1-A0D1-837B-A75C-B98D3AD69814}"/>
              </a:ext>
            </a:extLst>
          </p:cNvPr>
          <p:cNvSpPr txBox="1"/>
          <p:nvPr/>
        </p:nvSpPr>
        <p:spPr>
          <a:xfrm>
            <a:off x="-7866" y="4469060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6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6EC881B6-8EA4-6847-257F-3A2150A87C32}"/>
              </a:ext>
            </a:extLst>
          </p:cNvPr>
          <p:cNvSpPr/>
          <p:nvPr/>
        </p:nvSpPr>
        <p:spPr>
          <a:xfrm>
            <a:off x="1131528" y="4418259"/>
            <a:ext cx="4100871" cy="439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A098BB61-B24E-829F-83E6-E643DB958E03}"/>
              </a:ext>
            </a:extLst>
          </p:cNvPr>
          <p:cNvSpPr txBox="1"/>
          <p:nvPr/>
        </p:nvSpPr>
        <p:spPr>
          <a:xfrm>
            <a:off x="1379300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A070A117-C558-42C9-C3E3-407D6B43E87C}"/>
              </a:ext>
            </a:extLst>
          </p:cNvPr>
          <p:cNvSpPr txBox="1"/>
          <p:nvPr/>
        </p:nvSpPr>
        <p:spPr>
          <a:xfrm>
            <a:off x="3361401" y="577269"/>
            <a:ext cx="1759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7" name="Connettore diritto 16">
            <a:extLst>
              <a:ext uri="{FF2B5EF4-FFF2-40B4-BE49-F238E27FC236}">
                <a16:creationId xmlns:a16="http://schemas.microsoft.com/office/drawing/2014/main" id="{C0207B55-ABB1-24D0-BE86-469F01E6759E}"/>
              </a:ext>
            </a:extLst>
          </p:cNvPr>
          <p:cNvCxnSpPr/>
          <p:nvPr/>
        </p:nvCxnSpPr>
        <p:spPr>
          <a:xfrm>
            <a:off x="1290809" y="904568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diritto 17">
            <a:extLst>
              <a:ext uri="{FF2B5EF4-FFF2-40B4-BE49-F238E27FC236}">
                <a16:creationId xmlns:a16="http://schemas.microsoft.com/office/drawing/2014/main" id="{828A2434-6BE3-81F2-E6B6-8960A4E042AB}"/>
              </a:ext>
            </a:extLst>
          </p:cNvPr>
          <p:cNvCxnSpPr/>
          <p:nvPr/>
        </p:nvCxnSpPr>
        <p:spPr>
          <a:xfrm>
            <a:off x="3323711" y="888797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" name="Immagine 19">
            <a:extLst>
              <a:ext uri="{FF2B5EF4-FFF2-40B4-BE49-F238E27FC236}">
                <a16:creationId xmlns:a16="http://schemas.microsoft.com/office/drawing/2014/main" id="{2845E505-2E73-9721-D29E-BE23A67578D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2758" t="44457" r="8161" b="31335"/>
          <a:stretch>
            <a:fillRect/>
          </a:stretch>
        </p:blipFill>
        <p:spPr>
          <a:xfrm>
            <a:off x="557489" y="5312267"/>
            <a:ext cx="5242560" cy="1199023"/>
          </a:xfrm>
          <a:prstGeom prst="rect">
            <a:avLst/>
          </a:prstGeom>
        </p:spPr>
      </p:pic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88C7C74-CEBF-7304-4CAA-AA1FE59109D3}"/>
              </a:ext>
            </a:extLst>
          </p:cNvPr>
          <p:cNvSpPr txBox="1"/>
          <p:nvPr/>
        </p:nvSpPr>
        <p:spPr>
          <a:xfrm>
            <a:off x="5501147" y="5855841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MM20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D81AFC60-D35E-2507-68FE-EB22C346DB42}"/>
              </a:ext>
            </a:extLst>
          </p:cNvPr>
          <p:cNvSpPr txBox="1"/>
          <p:nvPr/>
        </p:nvSpPr>
        <p:spPr>
          <a:xfrm>
            <a:off x="0" y="5855843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014F964E-E3C3-61E6-1DBF-C455A9F7C6BB}"/>
              </a:ext>
            </a:extLst>
          </p:cNvPr>
          <p:cNvSpPr/>
          <p:nvPr/>
        </p:nvSpPr>
        <p:spPr>
          <a:xfrm>
            <a:off x="1185115" y="5774591"/>
            <a:ext cx="4100871" cy="439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5" name="Immagine 24">
            <a:extLst>
              <a:ext uri="{FF2B5EF4-FFF2-40B4-BE49-F238E27FC236}">
                <a16:creationId xmlns:a16="http://schemas.microsoft.com/office/drawing/2014/main" id="{17FC2642-6996-07EA-3DD7-8CDBA4CE727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4138" t="21683" r="14329" b="52997"/>
          <a:stretch>
            <a:fillRect/>
          </a:stretch>
        </p:blipFill>
        <p:spPr>
          <a:xfrm>
            <a:off x="6642592" y="946601"/>
            <a:ext cx="4742180" cy="1254120"/>
          </a:xfrm>
          <a:prstGeom prst="rect">
            <a:avLst/>
          </a:prstGeom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09595E6B-C72B-F436-6273-8778AFDCCC04}"/>
              </a:ext>
            </a:extLst>
          </p:cNvPr>
          <p:cNvSpPr txBox="1"/>
          <p:nvPr/>
        </p:nvSpPr>
        <p:spPr>
          <a:xfrm>
            <a:off x="7231460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6B3C1054-E6E5-1D99-BE2E-BFA8D941DDB5}"/>
              </a:ext>
            </a:extLst>
          </p:cNvPr>
          <p:cNvSpPr txBox="1"/>
          <p:nvPr/>
        </p:nvSpPr>
        <p:spPr>
          <a:xfrm>
            <a:off x="9213561" y="577269"/>
            <a:ext cx="1759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8" name="Connettore diritto 27">
            <a:extLst>
              <a:ext uri="{FF2B5EF4-FFF2-40B4-BE49-F238E27FC236}">
                <a16:creationId xmlns:a16="http://schemas.microsoft.com/office/drawing/2014/main" id="{F1CC005F-48B4-B3F3-1CED-1B58C9B63350}"/>
              </a:ext>
            </a:extLst>
          </p:cNvPr>
          <p:cNvCxnSpPr/>
          <p:nvPr/>
        </p:nvCxnSpPr>
        <p:spPr>
          <a:xfrm>
            <a:off x="7142969" y="904568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diritto 28">
            <a:extLst>
              <a:ext uri="{FF2B5EF4-FFF2-40B4-BE49-F238E27FC236}">
                <a16:creationId xmlns:a16="http://schemas.microsoft.com/office/drawing/2014/main" id="{039AE093-5DE8-2038-30BA-FD9463D63392}"/>
              </a:ext>
            </a:extLst>
          </p:cNvPr>
          <p:cNvCxnSpPr/>
          <p:nvPr/>
        </p:nvCxnSpPr>
        <p:spPr>
          <a:xfrm>
            <a:off x="9175871" y="888797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BDD03607-1E74-12B4-BFA5-BA558CA1544C}"/>
              </a:ext>
            </a:extLst>
          </p:cNvPr>
          <p:cNvSpPr txBox="1"/>
          <p:nvPr/>
        </p:nvSpPr>
        <p:spPr>
          <a:xfrm>
            <a:off x="11229749" y="1296662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PARKIN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B1170E5C-82FC-7FF7-92D2-33CDA5EB373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182" t="31321" r="16037" b="45822"/>
          <a:stretch>
            <a:fillRect/>
          </a:stretch>
        </p:blipFill>
        <p:spPr>
          <a:xfrm>
            <a:off x="6513873" y="2654814"/>
            <a:ext cx="5023876" cy="113214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35FB1024-3505-DF49-98DB-BAD75FC3CC8E}"/>
              </a:ext>
            </a:extLst>
          </p:cNvPr>
          <p:cNvSpPr txBox="1"/>
          <p:nvPr/>
        </p:nvSpPr>
        <p:spPr>
          <a:xfrm>
            <a:off x="6221274" y="1296661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5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9017860-8EDA-BE42-55A8-27050C0B5AD1}"/>
              </a:ext>
            </a:extLst>
          </p:cNvPr>
          <p:cNvSpPr txBox="1"/>
          <p:nvPr/>
        </p:nvSpPr>
        <p:spPr>
          <a:xfrm>
            <a:off x="11282112" y="2943885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RKIN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37E6602-E3A4-B609-1CDF-7DA62D77918A}"/>
              </a:ext>
            </a:extLst>
          </p:cNvPr>
          <p:cNvSpPr txBox="1"/>
          <p:nvPr/>
        </p:nvSpPr>
        <p:spPr>
          <a:xfrm>
            <a:off x="6373674" y="3041893"/>
            <a:ext cx="109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5 </a:t>
            </a:r>
            <a:r>
              <a:rPr lang="it-IT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Rettangolo 23">
            <a:extLst>
              <a:ext uri="{FF2B5EF4-FFF2-40B4-BE49-F238E27FC236}">
                <a16:creationId xmlns:a16="http://schemas.microsoft.com/office/drawing/2014/main" id="{6CA25AC1-9655-1BCE-9A81-6A147758F370}"/>
              </a:ext>
            </a:extLst>
          </p:cNvPr>
          <p:cNvSpPr/>
          <p:nvPr/>
        </p:nvSpPr>
        <p:spPr>
          <a:xfrm>
            <a:off x="6947330" y="3007327"/>
            <a:ext cx="4100871" cy="439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Rettangolo 30">
            <a:extLst>
              <a:ext uri="{FF2B5EF4-FFF2-40B4-BE49-F238E27FC236}">
                <a16:creationId xmlns:a16="http://schemas.microsoft.com/office/drawing/2014/main" id="{8BBAAEDD-2C65-3B6D-1B9D-EA9403863E5D}"/>
              </a:ext>
            </a:extLst>
          </p:cNvPr>
          <p:cNvSpPr/>
          <p:nvPr/>
        </p:nvSpPr>
        <p:spPr>
          <a:xfrm>
            <a:off x="6966990" y="1276847"/>
            <a:ext cx="3887822" cy="3421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4044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FC2EFD0C-D956-2674-9AF5-50AD4BE2B31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992" t="3333" r="5402" b="3333"/>
          <a:stretch>
            <a:fillRect/>
          </a:stretch>
        </p:blipFill>
        <p:spPr>
          <a:xfrm>
            <a:off x="538480" y="129969"/>
            <a:ext cx="4927600" cy="4159662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B1528CBB-646C-BE18-40FC-0DB1792A544D}"/>
              </a:ext>
            </a:extLst>
          </p:cNvPr>
          <p:cNvSpPr txBox="1"/>
          <p:nvPr/>
        </p:nvSpPr>
        <p:spPr>
          <a:xfrm>
            <a:off x="1379300" y="577269"/>
            <a:ext cx="1435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49159189-0EDB-7B07-078B-D629228E3759}"/>
              </a:ext>
            </a:extLst>
          </p:cNvPr>
          <p:cNvSpPr txBox="1"/>
          <p:nvPr/>
        </p:nvSpPr>
        <p:spPr>
          <a:xfrm>
            <a:off x="3361401" y="577269"/>
            <a:ext cx="1759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aka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EZR</a:t>
            </a:r>
            <a:r>
              <a:rPr lang="it-IT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" name="Connettore diritto 7">
            <a:extLst>
              <a:ext uri="{FF2B5EF4-FFF2-40B4-BE49-F238E27FC236}">
                <a16:creationId xmlns:a16="http://schemas.microsoft.com/office/drawing/2014/main" id="{A34ED527-D05D-B938-C226-47CE15C5235F}"/>
              </a:ext>
            </a:extLst>
          </p:cNvPr>
          <p:cNvCxnSpPr/>
          <p:nvPr/>
        </p:nvCxnSpPr>
        <p:spPr>
          <a:xfrm>
            <a:off x="1290809" y="904568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C9CE1DED-FE54-7A40-ADC1-8F83837456E9}"/>
              </a:ext>
            </a:extLst>
          </p:cNvPr>
          <p:cNvCxnSpPr/>
          <p:nvPr/>
        </p:nvCxnSpPr>
        <p:spPr>
          <a:xfrm>
            <a:off x="3323711" y="888797"/>
            <a:ext cx="15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3FD0250-99C6-E8FA-955F-364BC310F77B}"/>
              </a:ext>
            </a:extLst>
          </p:cNvPr>
          <p:cNvSpPr txBox="1"/>
          <p:nvPr/>
        </p:nvSpPr>
        <p:spPr>
          <a:xfrm>
            <a:off x="6337057" y="577269"/>
            <a:ext cx="2502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ain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ree membrane</a:t>
            </a:r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D4B449B4-DAA5-DC51-B57E-4A0BBDBC68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694465"/>
            <a:ext cx="3738442" cy="2793088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D9A9307E-C9C1-D8C7-8B5E-692D4A958613}"/>
              </a:ext>
            </a:extLst>
          </p:cNvPr>
          <p:cNvSpPr txBox="1"/>
          <p:nvPr/>
        </p:nvSpPr>
        <p:spPr>
          <a:xfrm>
            <a:off x="821649" y="118969"/>
            <a:ext cx="109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6 B</a:t>
            </a: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6FFCF189-0AD7-FEEB-48E1-53D3444AFAF6}"/>
              </a:ext>
            </a:extLst>
          </p:cNvPr>
          <p:cNvSpPr/>
          <p:nvPr/>
        </p:nvSpPr>
        <p:spPr>
          <a:xfrm>
            <a:off x="958312" y="2310258"/>
            <a:ext cx="4233448" cy="2038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01A3DD1-7D94-C859-4F52-7D1726D0AF17}"/>
              </a:ext>
            </a:extLst>
          </p:cNvPr>
          <p:cNvSpPr txBox="1"/>
          <p:nvPr/>
        </p:nvSpPr>
        <p:spPr>
          <a:xfrm>
            <a:off x="572576" y="2146142"/>
            <a:ext cx="4981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it-IT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40718667-AEC4-2235-4086-0DE91D9418E2}"/>
              </a:ext>
            </a:extLst>
          </p:cNvPr>
          <p:cNvSpPr txBox="1"/>
          <p:nvPr/>
        </p:nvSpPr>
        <p:spPr>
          <a:xfrm>
            <a:off x="621120" y="2668590"/>
            <a:ext cx="4010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48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AD0F0BB-CEA9-FF48-FDD0-68E40A49C34F}"/>
              </a:ext>
            </a:extLst>
          </p:cNvPr>
          <p:cNvSpPr txBox="1"/>
          <p:nvPr/>
        </p:nvSpPr>
        <p:spPr>
          <a:xfrm>
            <a:off x="609207" y="2399897"/>
            <a:ext cx="3741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55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FC4A8099-1865-EEE9-6272-92C1B548ECA6}"/>
              </a:ext>
            </a:extLst>
          </p:cNvPr>
          <p:cNvSpPr txBox="1"/>
          <p:nvPr/>
        </p:nvSpPr>
        <p:spPr>
          <a:xfrm>
            <a:off x="617558" y="2867465"/>
            <a:ext cx="3438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F5F07EA6-3C02-1F2F-0C61-0CD9F95EE0DB}"/>
              </a:ext>
            </a:extLst>
          </p:cNvPr>
          <p:cNvSpPr txBox="1"/>
          <p:nvPr/>
        </p:nvSpPr>
        <p:spPr>
          <a:xfrm>
            <a:off x="617558" y="3091009"/>
            <a:ext cx="3826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30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262B80F3-5FAE-EDD4-33FE-F753AD10FF38}"/>
              </a:ext>
            </a:extLst>
          </p:cNvPr>
          <p:cNvSpPr txBox="1"/>
          <p:nvPr/>
        </p:nvSpPr>
        <p:spPr>
          <a:xfrm>
            <a:off x="626997" y="3429000"/>
            <a:ext cx="3385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25FA7979-829F-0379-5C6E-F8C2BAEB0608}"/>
              </a:ext>
            </a:extLst>
          </p:cNvPr>
          <p:cNvSpPr txBox="1"/>
          <p:nvPr/>
        </p:nvSpPr>
        <p:spPr>
          <a:xfrm>
            <a:off x="5208737" y="2500763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V ATP5A 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D2F95523-87E8-E9F0-A8E6-0147A92A8603}"/>
              </a:ext>
            </a:extLst>
          </p:cNvPr>
          <p:cNvSpPr txBox="1"/>
          <p:nvPr/>
        </p:nvSpPr>
        <p:spPr>
          <a:xfrm>
            <a:off x="5203559" y="3036585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V MTCO1 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61DB5594-2F95-A204-3ED1-50005E0F7229}"/>
              </a:ext>
            </a:extLst>
          </p:cNvPr>
          <p:cNvSpPr txBox="1"/>
          <p:nvPr/>
        </p:nvSpPr>
        <p:spPr>
          <a:xfrm>
            <a:off x="5205387" y="3559805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 NDUFB8 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1E819CFD-E82E-6B5A-7137-CBF63E19D6A7}"/>
              </a:ext>
            </a:extLst>
          </p:cNvPr>
          <p:cNvSpPr txBox="1"/>
          <p:nvPr/>
        </p:nvSpPr>
        <p:spPr>
          <a:xfrm>
            <a:off x="5201438" y="2702031"/>
            <a:ext cx="9140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II UQCRC2 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C9E23769-937F-B547-0E62-647C8AEEBB60}"/>
              </a:ext>
            </a:extLst>
          </p:cNvPr>
          <p:cNvSpPr txBox="1"/>
          <p:nvPr/>
        </p:nvSpPr>
        <p:spPr>
          <a:xfrm>
            <a:off x="5198577" y="3181513"/>
            <a:ext cx="7417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Calibri" panose="020F0502020204030204" pitchFamily="34" charset="0"/>
                <a:cs typeface="Calibri" panose="020F0502020204030204" pitchFamily="34" charset="0"/>
              </a:rPr>
              <a:t>CII SDHB </a:t>
            </a:r>
          </a:p>
        </p:txBody>
      </p:sp>
    </p:spTree>
    <p:extLst>
      <p:ext uri="{BB962C8B-B14F-4D97-AF65-F5344CB8AC3E}">
        <p14:creationId xmlns:p14="http://schemas.microsoft.com/office/powerpoint/2010/main" val="21729263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140</Words>
  <Application>Microsoft Office PowerPoint</Application>
  <PresentationFormat>Widescreen</PresentationFormat>
  <Paragraphs>73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landa Carratù</dc:creator>
  <cp:lastModifiedBy>Iolanda Carratù</cp:lastModifiedBy>
  <cp:revision>2</cp:revision>
  <dcterms:created xsi:type="dcterms:W3CDTF">2025-07-21T13:03:41Z</dcterms:created>
  <dcterms:modified xsi:type="dcterms:W3CDTF">2025-07-21T18:28:11Z</dcterms:modified>
</cp:coreProperties>
</file>